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4577" r:id="rId2"/>
  </p:sldIdLst>
  <p:sldSz cx="12599988" cy="11123613"/>
  <p:notesSz cx="994568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30151F7A-BFFD-48C0-A0C3-EEF577555DD8}">
          <p14:sldIdLst>
            <p14:sldId id="14577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390" userDrawn="1">
          <p15:clr>
            <a:srgbClr val="A4A3A4"/>
          </p15:clr>
        </p15:guide>
        <p15:guide id="2" pos="399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吉田 崇" initials="吉田" lastIdx="7" clrIdx="0">
    <p:extLst>
      <p:ext uri="{19B8F6BF-5375-455C-9EA6-DF929625EA0E}">
        <p15:presenceInfo xmlns:p15="http://schemas.microsoft.com/office/powerpoint/2012/main" userId="abc0f7d0d71e4a90" providerId="Windows Live"/>
      </p:ext>
    </p:extLst>
  </p:cmAuthor>
  <p:cmAuthor id="2" name="Chisato Ohe" initials="CO" lastIdx="1" clrIdx="1">
    <p:extLst>
      <p:ext uri="{19B8F6BF-5375-455C-9EA6-DF929625EA0E}">
        <p15:presenceInfo xmlns:p15="http://schemas.microsoft.com/office/powerpoint/2012/main" userId="94b96197138b5a8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FF"/>
    <a:srgbClr val="00B050"/>
    <a:srgbClr val="A50021"/>
    <a:srgbClr val="FFF3FF"/>
    <a:srgbClr val="FCC8DC"/>
    <a:srgbClr val="FFCCFF"/>
    <a:srgbClr val="FFCCCC"/>
    <a:srgbClr val="FFCC99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1732" autoAdjust="0"/>
  </p:normalViewPr>
  <p:slideViewPr>
    <p:cSldViewPr snapToGrid="0">
      <p:cViewPr varScale="1">
        <p:scale>
          <a:sx n="46" d="100"/>
          <a:sy n="46" d="100"/>
        </p:scale>
        <p:origin x="763" y="62"/>
      </p:cViewPr>
      <p:guideLst>
        <p:guide orient="horz" pos="3390"/>
        <p:guide pos="399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9799" cy="341542"/>
          </a:xfrm>
          <a:prstGeom prst="rect">
            <a:avLst/>
          </a:prstGeom>
        </p:spPr>
        <p:txBody>
          <a:bodyPr vert="horz" lIns="91430" tIns="45716" rIns="91430" bIns="4571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33590" y="0"/>
            <a:ext cx="4309799" cy="341542"/>
          </a:xfrm>
          <a:prstGeom prst="rect">
            <a:avLst/>
          </a:prstGeom>
        </p:spPr>
        <p:txBody>
          <a:bodyPr vert="horz" lIns="91430" tIns="45716" rIns="91430" bIns="45716" rtlCol="0"/>
          <a:lstStyle>
            <a:lvl1pPr algn="r">
              <a:defRPr sz="1200"/>
            </a:lvl1pPr>
          </a:lstStyle>
          <a:p>
            <a:fld id="{E51BCC0A-7EC9-47D8-A0F9-17BEC50094D8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671888" y="850900"/>
            <a:ext cx="2601912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0" tIns="45716" rIns="91430" bIns="45716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4569" y="3275966"/>
            <a:ext cx="7956550" cy="2680335"/>
          </a:xfrm>
          <a:prstGeom prst="rect">
            <a:avLst/>
          </a:prstGeom>
        </p:spPr>
        <p:txBody>
          <a:bodyPr vert="horz" lIns="91430" tIns="45716" rIns="91430" bIns="45716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6465659"/>
            <a:ext cx="4309799" cy="341542"/>
          </a:xfrm>
          <a:prstGeom prst="rect">
            <a:avLst/>
          </a:prstGeom>
        </p:spPr>
        <p:txBody>
          <a:bodyPr vert="horz" lIns="91430" tIns="45716" rIns="91430" bIns="4571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33590" y="6465659"/>
            <a:ext cx="4309799" cy="341542"/>
          </a:xfrm>
          <a:prstGeom prst="rect">
            <a:avLst/>
          </a:prstGeom>
        </p:spPr>
        <p:txBody>
          <a:bodyPr vert="horz" lIns="91430" tIns="45716" rIns="91430" bIns="45716" rtlCol="0" anchor="b"/>
          <a:lstStyle>
            <a:lvl1pPr algn="r">
              <a:defRPr sz="1200"/>
            </a:lvl1pPr>
          </a:lstStyle>
          <a:p>
            <a:fld id="{1226C3D7-30D9-46E8-9692-0075B7D4F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5691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33272" rtl="0" eaLnBrk="1" latinLnBrk="0" hangingPunct="1">
      <a:defRPr kumimoji="1" sz="1356" kern="1200">
        <a:solidFill>
          <a:schemeClr val="tx1"/>
        </a:solidFill>
        <a:latin typeface="+mn-lt"/>
        <a:ea typeface="+mn-ea"/>
        <a:cs typeface="+mn-cs"/>
      </a:defRPr>
    </a:lvl1pPr>
    <a:lvl2pPr marL="516636" algn="l" defTabSz="1033272" rtl="0" eaLnBrk="1" latinLnBrk="0" hangingPunct="1">
      <a:defRPr kumimoji="1" sz="1356" kern="1200">
        <a:solidFill>
          <a:schemeClr val="tx1"/>
        </a:solidFill>
        <a:latin typeface="+mn-lt"/>
        <a:ea typeface="+mn-ea"/>
        <a:cs typeface="+mn-cs"/>
      </a:defRPr>
    </a:lvl2pPr>
    <a:lvl3pPr marL="1033272" algn="l" defTabSz="1033272" rtl="0" eaLnBrk="1" latinLnBrk="0" hangingPunct="1">
      <a:defRPr kumimoji="1" sz="1356" kern="1200">
        <a:solidFill>
          <a:schemeClr val="tx1"/>
        </a:solidFill>
        <a:latin typeface="+mn-lt"/>
        <a:ea typeface="+mn-ea"/>
        <a:cs typeface="+mn-cs"/>
      </a:defRPr>
    </a:lvl3pPr>
    <a:lvl4pPr marL="1549908" algn="l" defTabSz="1033272" rtl="0" eaLnBrk="1" latinLnBrk="0" hangingPunct="1">
      <a:defRPr kumimoji="1" sz="1356" kern="1200">
        <a:solidFill>
          <a:schemeClr val="tx1"/>
        </a:solidFill>
        <a:latin typeface="+mn-lt"/>
        <a:ea typeface="+mn-ea"/>
        <a:cs typeface="+mn-cs"/>
      </a:defRPr>
    </a:lvl4pPr>
    <a:lvl5pPr marL="2066544" algn="l" defTabSz="1033272" rtl="0" eaLnBrk="1" latinLnBrk="0" hangingPunct="1">
      <a:defRPr kumimoji="1" sz="1356" kern="1200">
        <a:solidFill>
          <a:schemeClr val="tx1"/>
        </a:solidFill>
        <a:latin typeface="+mn-lt"/>
        <a:ea typeface="+mn-ea"/>
        <a:cs typeface="+mn-cs"/>
      </a:defRPr>
    </a:lvl5pPr>
    <a:lvl6pPr marL="2583180" algn="l" defTabSz="1033272" rtl="0" eaLnBrk="1" latinLnBrk="0" hangingPunct="1">
      <a:defRPr kumimoji="1" sz="1356" kern="1200">
        <a:solidFill>
          <a:schemeClr val="tx1"/>
        </a:solidFill>
        <a:latin typeface="+mn-lt"/>
        <a:ea typeface="+mn-ea"/>
        <a:cs typeface="+mn-cs"/>
      </a:defRPr>
    </a:lvl6pPr>
    <a:lvl7pPr marL="3099816" algn="l" defTabSz="1033272" rtl="0" eaLnBrk="1" latinLnBrk="0" hangingPunct="1">
      <a:defRPr kumimoji="1" sz="1356" kern="1200">
        <a:solidFill>
          <a:schemeClr val="tx1"/>
        </a:solidFill>
        <a:latin typeface="+mn-lt"/>
        <a:ea typeface="+mn-ea"/>
        <a:cs typeface="+mn-cs"/>
      </a:defRPr>
    </a:lvl7pPr>
    <a:lvl8pPr marL="3616452" algn="l" defTabSz="1033272" rtl="0" eaLnBrk="1" latinLnBrk="0" hangingPunct="1">
      <a:defRPr kumimoji="1" sz="1356" kern="1200">
        <a:solidFill>
          <a:schemeClr val="tx1"/>
        </a:solidFill>
        <a:latin typeface="+mn-lt"/>
        <a:ea typeface="+mn-ea"/>
        <a:cs typeface="+mn-cs"/>
      </a:defRPr>
    </a:lvl8pPr>
    <a:lvl9pPr marL="4133088" algn="l" defTabSz="1033272" rtl="0" eaLnBrk="1" latinLnBrk="0" hangingPunct="1">
      <a:defRPr kumimoji="1" sz="13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1820463"/>
            <a:ext cx="10709990" cy="3872665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5842472"/>
            <a:ext cx="9449991" cy="2685631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6333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454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592229"/>
            <a:ext cx="2716872" cy="942674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592229"/>
            <a:ext cx="7993117" cy="942674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426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87692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2773182"/>
            <a:ext cx="10867490" cy="4627113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7444069"/>
            <a:ext cx="10867490" cy="2433290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985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2961147"/>
            <a:ext cx="5354995" cy="705783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2961147"/>
            <a:ext cx="5354995" cy="705783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109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92232"/>
            <a:ext cx="10867490" cy="215005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2726831"/>
            <a:ext cx="5330385" cy="133637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4063209"/>
            <a:ext cx="5330385" cy="597636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2726831"/>
            <a:ext cx="5356636" cy="133637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4063209"/>
            <a:ext cx="5356636" cy="597636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263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5775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5851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741574"/>
            <a:ext cx="4063824" cy="2595510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601597"/>
            <a:ext cx="6378744" cy="7904975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337084"/>
            <a:ext cx="4063824" cy="618236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7819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741574"/>
            <a:ext cx="4063824" cy="2595510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601597"/>
            <a:ext cx="6378744" cy="7904975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337084"/>
            <a:ext cx="4063824" cy="618236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9589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592232"/>
            <a:ext cx="10867490" cy="21500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2961147"/>
            <a:ext cx="10867490" cy="70578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10309944"/>
            <a:ext cx="2834997" cy="5922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E1A91F-58C9-4812-8A86-241CD3D7E731}" type="datetimeFigureOut">
              <a:rPr kumimoji="1" lang="ja-JP" altLang="en-US" smtClean="0"/>
              <a:t>2024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10309944"/>
            <a:ext cx="4252496" cy="5922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10309944"/>
            <a:ext cx="2834997" cy="5922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15485-7FE5-4EF7-99BA-42C1F1E2D2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4284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60043" rtl="0" eaLnBrk="1" latinLnBrk="0" hangingPunct="1">
        <a:lnSpc>
          <a:spcPct val="90000"/>
        </a:lnSpc>
        <a:spcBef>
          <a:spcPct val="0"/>
        </a:spcBef>
        <a:buNone/>
        <a:defRPr kumimoji="1"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l" defTabSz="1260043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kumimoji="1"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kumimoji="1"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043" rtl="0" eaLnBrk="1" latinLnBrk="0" hangingPunct="1"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l" defTabSz="1260043" rtl="0" eaLnBrk="1" latinLnBrk="0" hangingPunct="1"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l" defTabSz="1260043" rtl="0" eaLnBrk="1" latinLnBrk="0" hangingPunct="1"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l" defTabSz="1260043" rtl="0" eaLnBrk="1" latinLnBrk="0" hangingPunct="1"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l" defTabSz="1260043" rtl="0" eaLnBrk="1" latinLnBrk="0" hangingPunct="1"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l" defTabSz="1260043" rtl="0" eaLnBrk="1" latinLnBrk="0" hangingPunct="1"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l" defTabSz="1260043" rtl="0" eaLnBrk="1" latinLnBrk="0" hangingPunct="1"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l" defTabSz="1260043" rtl="0" eaLnBrk="1" latinLnBrk="0" hangingPunct="1"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l" defTabSz="1260043" rtl="0" eaLnBrk="1" latinLnBrk="0" hangingPunct="1">
        <a:defRPr kumimoji="1"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41">
            <a:extLst>
              <a:ext uri="{FF2B5EF4-FFF2-40B4-BE49-F238E27FC236}">
                <a16:creationId xmlns:a16="http://schemas.microsoft.com/office/drawing/2014/main" id="{E9A4FD67-388B-385A-5494-BBD061DE019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000" y="3356808"/>
            <a:ext cx="4278746" cy="2692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テキスト ボックス 42">
            <a:extLst>
              <a:ext uri="{FF2B5EF4-FFF2-40B4-BE49-F238E27FC236}">
                <a16:creationId xmlns:a16="http://schemas.microsoft.com/office/drawing/2014/main" id="{88C88549-B339-676A-9A67-047AC8B130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4997" y="3387434"/>
            <a:ext cx="1994998" cy="389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9pPr>
          </a:lstStyle>
          <a:p>
            <a:pPr algn="r"/>
            <a:r>
              <a:rPr lang="en-US" altLang="ja-JP" sz="1929" dirty="0">
                <a:ea typeface="ＭＳ Ｐゴシック" panose="020B0600070205080204" pitchFamily="50" charset="-128"/>
              </a:rPr>
              <a:t>TCGA-BP-4985</a:t>
            </a:r>
            <a:endParaRPr lang="ja-JP" altLang="en-US" sz="1929" dirty="0">
              <a:ea typeface="ＭＳ Ｐゴシック" panose="020B0600070205080204" pitchFamily="50" charset="-128"/>
            </a:endParaRPr>
          </a:p>
        </p:txBody>
      </p:sp>
      <p:pic>
        <p:nvPicPr>
          <p:cNvPr id="6" name="図 43">
            <a:extLst>
              <a:ext uri="{FF2B5EF4-FFF2-40B4-BE49-F238E27FC236}">
                <a16:creationId xmlns:a16="http://schemas.microsoft.com/office/drawing/2014/main" id="{60F0DB67-D303-71D3-6750-7DA693D369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57" r="911" b="5222"/>
          <a:stretch>
            <a:fillRect/>
          </a:stretch>
        </p:blipFill>
        <p:spPr bwMode="auto">
          <a:xfrm>
            <a:off x="4934996" y="3356809"/>
            <a:ext cx="3462810" cy="27059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図 44">
            <a:extLst>
              <a:ext uri="{FF2B5EF4-FFF2-40B4-BE49-F238E27FC236}">
                <a16:creationId xmlns:a16="http://schemas.microsoft.com/office/drawing/2014/main" id="{36EDC398-1D98-F348-A26A-04C948784AD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29" r="20757" b="4942"/>
          <a:stretch>
            <a:fillRect/>
          </a:stretch>
        </p:blipFill>
        <p:spPr bwMode="auto">
          <a:xfrm>
            <a:off x="8504992" y="3356809"/>
            <a:ext cx="3464997" cy="2716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正方形/長方形 46">
            <a:extLst>
              <a:ext uri="{FF2B5EF4-FFF2-40B4-BE49-F238E27FC236}">
                <a16:creationId xmlns:a16="http://schemas.microsoft.com/office/drawing/2014/main" id="{88B6978E-6690-6172-FF00-5307A41CC8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9999" y="5170244"/>
            <a:ext cx="216563" cy="181563"/>
          </a:xfrm>
          <a:prstGeom prst="rect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defTabSz="566738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1pPr>
            <a:lvl2pPr marL="742950" indent="-285750" defTabSz="566738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2pPr>
            <a:lvl3pPr marL="1143000" indent="-228600" defTabSz="566738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3pPr>
            <a:lvl4pPr marL="1600200" indent="-228600" defTabSz="566738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4pPr>
            <a:lvl5pPr marL="2057400" indent="-228600" defTabSz="566738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5pPr>
            <a:lvl6pPr marL="2514600" indent="-228600" defTabSz="566738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6pPr>
            <a:lvl7pPr marL="2971800" indent="-228600" defTabSz="566738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7pPr>
            <a:lvl8pPr marL="3429000" indent="-228600" defTabSz="566738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8pPr>
            <a:lvl9pPr marL="3886200" indent="-228600" defTabSz="566738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9pPr>
          </a:lstStyle>
          <a:p>
            <a:pPr eaLnBrk="1" hangingPunct="1"/>
            <a:endParaRPr lang="ja-JP" altLang="en-US" sz="2756">
              <a:ea typeface="ＭＳ Ｐゴシック" panose="020B0600070205080204" pitchFamily="50" charset="-128"/>
            </a:endParaRPr>
          </a:p>
        </p:txBody>
      </p:sp>
      <p:sp>
        <p:nvSpPr>
          <p:cNvPr id="9" name="正方形/長方形 47">
            <a:extLst>
              <a:ext uri="{FF2B5EF4-FFF2-40B4-BE49-F238E27FC236}">
                <a16:creationId xmlns:a16="http://schemas.microsoft.com/office/drawing/2014/main" id="{A7186953-D3F3-D12F-2767-67B1C4D9C4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74999" y="4406808"/>
            <a:ext cx="209998" cy="209998"/>
          </a:xfrm>
          <a:prstGeom prst="rect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defTabSz="566738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1pPr>
            <a:lvl2pPr marL="742950" indent="-285750" defTabSz="566738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2pPr>
            <a:lvl3pPr marL="1143000" indent="-228600" defTabSz="566738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3pPr>
            <a:lvl4pPr marL="1600200" indent="-228600" defTabSz="566738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4pPr>
            <a:lvl5pPr marL="2057400" indent="-228600" defTabSz="566738"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5pPr>
            <a:lvl6pPr marL="2514600" indent="-228600" defTabSz="566738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6pPr>
            <a:lvl7pPr marL="2971800" indent="-228600" defTabSz="566738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7pPr>
            <a:lvl8pPr marL="3429000" indent="-228600" defTabSz="566738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8pPr>
            <a:lvl9pPr marL="3886200" indent="-228600" defTabSz="566738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Helvetica" panose="020B0604020202020204" pitchFamily="34" charset="0"/>
              </a:defRPr>
            </a:lvl9pPr>
          </a:lstStyle>
          <a:p>
            <a:pPr eaLnBrk="1" hangingPunct="1"/>
            <a:endParaRPr lang="ja-JP" altLang="en-US" sz="2756">
              <a:ea typeface="ＭＳ Ｐゴシック" panose="020B0600070205080204" pitchFamily="50" charset="-128"/>
            </a:endParaRPr>
          </a:p>
        </p:txBody>
      </p:sp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05249F6E-1AE2-C268-D94B-10D50CD128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2633231"/>
              </p:ext>
            </p:extLst>
          </p:nvPr>
        </p:nvGraphicFramePr>
        <p:xfrm>
          <a:off x="420000" y="6191806"/>
          <a:ext cx="11759988" cy="2331875"/>
        </p:xfrm>
        <a:graphic>
          <a:graphicData uri="http://schemas.openxmlformats.org/drawingml/2006/table">
            <a:tbl>
              <a:tblPr/>
              <a:tblGrid>
                <a:gridCol w="43049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7999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77499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66375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Histological features</a:t>
                      </a:r>
                      <a:endParaRPr kumimoji="1" lang="ja-JP" altLang="en-US" sz="22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Assessment by a urologic pathologist</a:t>
                      </a:r>
                      <a:endParaRPr kumimoji="1" lang="ja-JP" altLang="en-US" sz="22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66375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WHO/ISUP grade</a:t>
                      </a:r>
                      <a:endParaRPr kumimoji="1" lang="ja-JP" altLang="en-US" sz="2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Grade 3</a:t>
                      </a:r>
                      <a:endParaRPr kumimoji="1" lang="ja-JP" altLang="en-US" sz="2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defTabSz="944563"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 defTabSz="944563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 defTabSz="944563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 defTabSz="944563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 defTabSz="944563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defTabSz="944563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defTabSz="944563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defTabSz="944563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defTabSz="944563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44563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Visible eosinophilic nucleolus</a:t>
                      </a: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66375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Cytological phenotype</a:t>
                      </a:r>
                      <a:endParaRPr kumimoji="1" lang="ja-JP" altLang="en-US" sz="2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Mixed</a:t>
                      </a:r>
                      <a:endParaRPr kumimoji="1" lang="ja-JP" altLang="en-US" sz="2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Intermingle with clear and eosinophilic cells</a:t>
                      </a: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66375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Vascularity-based classification</a:t>
                      </a:r>
                      <a:endParaRPr kumimoji="1" lang="ja-JP" altLang="en-US" sz="2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Category 2</a:t>
                      </a: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Papillary/Pseudopapillary</a:t>
                      </a:r>
                      <a:endParaRPr kumimoji="1" lang="ja-JP" altLang="en-US" sz="2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66375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Immunophenotype</a:t>
                      </a:r>
                      <a:endParaRPr kumimoji="1" lang="ja-JP" altLang="en-US" sz="2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Inflamed</a:t>
                      </a:r>
                      <a:endParaRPr kumimoji="1" lang="ja-JP" altLang="en-US" sz="2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8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7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6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sz="4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ＭＳ Ｐゴシック" panose="020B0600070205080204" pitchFamily="50" charset="-128"/>
                          <a:cs typeface="Helvetica" panose="020B0604020202020204" pitchFamily="34" charset="0"/>
                        </a:rPr>
                        <a:t>Intratumor immune infiltration</a:t>
                      </a:r>
                      <a:endParaRPr kumimoji="1" lang="ja-JP" altLang="en-US" sz="2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ea typeface="ＭＳ Ｐゴシック" panose="020B0600070205080204" pitchFamily="50" charset="-128"/>
                        <a:cs typeface="Helvetica" panose="020B0604020202020204" pitchFamily="34" charset="0"/>
                      </a:endParaRPr>
                    </a:p>
                  </a:txBody>
                  <a:tcPr marL="130216" marR="130216" marT="65130" marB="6513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pic>
        <p:nvPicPr>
          <p:cNvPr id="12" name="図 11">
            <a:extLst>
              <a:ext uri="{FF2B5EF4-FFF2-40B4-BE49-F238E27FC236}">
                <a16:creationId xmlns:a16="http://schemas.microsoft.com/office/drawing/2014/main" id="{B7FAA187-2E59-70B7-413A-4D3E06EABE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04992" y="3356809"/>
            <a:ext cx="3884996" cy="269504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3F4535B-1DF1-4655-8048-5858E54B8ED2}"/>
              </a:ext>
            </a:extLst>
          </p:cNvPr>
          <p:cNvSpPr txBox="1"/>
          <p:nvPr/>
        </p:nvSpPr>
        <p:spPr>
          <a:xfrm>
            <a:off x="410160" y="941645"/>
            <a:ext cx="11979828" cy="7156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</a:t>
            </a:r>
            <a:r>
              <a:rPr lang="en-US" altLang="ja-JP" sz="2400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Examples of how to determine the </a:t>
            </a:r>
            <a:r>
              <a:rPr lang="en-US" altLang="ja-JP" sz="24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tholo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ical parameters.</a:t>
            </a:r>
            <a:endParaRPr lang="ja-JP" altLang="ja-JP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2031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8</TotalTime>
  <Words>51</Words>
  <Application>Microsoft Office PowerPoint</Application>
  <PresentationFormat>ユーザー設定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Century</vt:lpstr>
      <vt:lpstr>Helvetica</vt:lpstr>
      <vt:lpstr>Office テーマ</vt:lpstr>
      <vt:lpstr>PowerPoint プレゼンテーション</vt:lpstr>
    </vt:vector>
  </TitlesOfParts>
  <Company>関西医科大学医学部附属病院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byouri</dc:creator>
  <cp:lastModifiedBy>Ohe Chisato</cp:lastModifiedBy>
  <cp:revision>50</cp:revision>
  <cp:lastPrinted>2021-08-17T05:25:25Z</cp:lastPrinted>
  <dcterms:created xsi:type="dcterms:W3CDTF">2021-06-10T01:35:07Z</dcterms:created>
  <dcterms:modified xsi:type="dcterms:W3CDTF">2024-11-15T09:07:09Z</dcterms:modified>
</cp:coreProperties>
</file>